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60" r:id="rId5"/>
    <p:sldId id="259" r:id="rId6"/>
    <p:sldId id="256" r:id="rId7"/>
    <p:sldId id="257" r:id="rId8"/>
    <p:sldId id="258" r:id="rId9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5" d="100"/>
          <a:sy n="125" d="100"/>
        </p:scale>
        <p:origin x="162" y="-231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36E36-0259-4EA8-8BA9-E7595B172C14}" type="datetimeFigureOut">
              <a:rPr lang="en-GB" smtClean="0"/>
              <a:t>27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351C9-AF9F-4151-9388-089E4368D9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11213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36E36-0259-4EA8-8BA9-E7595B172C14}" type="datetimeFigureOut">
              <a:rPr lang="en-GB" smtClean="0"/>
              <a:t>27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351C9-AF9F-4151-9388-089E4368D9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7056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36E36-0259-4EA8-8BA9-E7595B172C14}" type="datetimeFigureOut">
              <a:rPr lang="en-GB" smtClean="0"/>
              <a:t>27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351C9-AF9F-4151-9388-089E4368D9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19596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36E36-0259-4EA8-8BA9-E7595B172C14}" type="datetimeFigureOut">
              <a:rPr lang="en-GB" smtClean="0"/>
              <a:t>27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351C9-AF9F-4151-9388-089E4368D9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58113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36E36-0259-4EA8-8BA9-E7595B172C14}" type="datetimeFigureOut">
              <a:rPr lang="en-GB" smtClean="0"/>
              <a:t>27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351C9-AF9F-4151-9388-089E4368D9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26345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36E36-0259-4EA8-8BA9-E7595B172C14}" type="datetimeFigureOut">
              <a:rPr lang="en-GB" smtClean="0"/>
              <a:t>27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351C9-AF9F-4151-9388-089E4368D9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13119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36E36-0259-4EA8-8BA9-E7595B172C14}" type="datetimeFigureOut">
              <a:rPr lang="en-GB" smtClean="0"/>
              <a:t>27/09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351C9-AF9F-4151-9388-089E4368D9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60037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36E36-0259-4EA8-8BA9-E7595B172C14}" type="datetimeFigureOut">
              <a:rPr lang="en-GB" smtClean="0"/>
              <a:t>27/09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351C9-AF9F-4151-9388-089E4368D9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30993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36E36-0259-4EA8-8BA9-E7595B172C14}" type="datetimeFigureOut">
              <a:rPr lang="en-GB" smtClean="0"/>
              <a:t>27/09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351C9-AF9F-4151-9388-089E4368D9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75851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36E36-0259-4EA8-8BA9-E7595B172C14}" type="datetimeFigureOut">
              <a:rPr lang="en-GB" smtClean="0"/>
              <a:t>27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351C9-AF9F-4151-9388-089E4368D9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78949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336E36-0259-4EA8-8BA9-E7595B172C14}" type="datetimeFigureOut">
              <a:rPr lang="en-GB" smtClean="0"/>
              <a:t>27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B351C9-AF9F-4151-9388-089E4368D9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26337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336E36-0259-4EA8-8BA9-E7595B172C14}" type="datetimeFigureOut">
              <a:rPr lang="en-GB" smtClean="0"/>
              <a:t>27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B351C9-AF9F-4151-9388-089E4368D970}" type="slidenum">
              <a:rPr lang="en-GB" smtClean="0"/>
              <a:t>‹#›</a:t>
            </a:fld>
            <a:endParaRPr lang="en-GB"/>
          </a:p>
        </p:txBody>
      </p:sp>
      <p:sp>
        <p:nvSpPr>
          <p:cNvPr id="8" name="textruta 7">
            <a:extLst>
              <a:ext uri="{FF2B5EF4-FFF2-40B4-BE49-F238E27FC236}">
                <a16:creationId xmlns:a16="http://schemas.microsoft.com/office/drawing/2014/main" id="{D48E63FC-F886-08C5-5B0D-7E7FE320FBD7}"/>
              </a:ext>
            </a:extLst>
          </p:cNvPr>
          <p:cNvSpPr txBox="1"/>
          <p:nvPr>
            <p:extLst>
              <p:ext uri="{1162E1C5-73C7-4A58-AE30-91384D911F3F}">
                <p184:classification xmlns="" xmlns:p184="http://schemas.microsoft.com/office/powerpoint/2018/4/main" val="hdr"/>
              </p:ext>
            </p:extLst>
          </p:nvPr>
        </p:nvSpPr>
        <p:spPr>
          <a:xfrm>
            <a:off x="6029325" y="63500"/>
            <a:ext cx="787400" cy="121920"/>
          </a:xfrm>
          <a:prstGeom prst="rect">
            <a:avLst/>
          </a:prstGeom>
        </p:spPr>
        <p:txBody>
          <a:bodyPr horzOverflow="overflow" lIns="0" tIns="0" rIns="0" bIns="0">
            <a:spAutoFit/>
          </a:bodyPr>
          <a:lstStyle/>
          <a:p>
            <a:pPr algn="l"/>
            <a:r>
              <a:rPr lang="sv-SE" sz="80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egränsad delning</a:t>
            </a:r>
          </a:p>
        </p:txBody>
      </p:sp>
    </p:spTree>
    <p:extLst>
      <p:ext uri="{BB962C8B-B14F-4D97-AF65-F5344CB8AC3E}">
        <p14:creationId xmlns:p14="http://schemas.microsoft.com/office/powerpoint/2010/main" val="26546864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A296F0E-BD14-4D5B-A1FB-6471B39E1B0D}"/>
              </a:ext>
            </a:extLst>
          </p:cNvPr>
          <p:cNvSpPr txBox="1"/>
          <p:nvPr/>
        </p:nvSpPr>
        <p:spPr>
          <a:xfrm>
            <a:off x="173267" y="144530"/>
            <a:ext cx="48982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ea typeface="Tahoma" panose="020B0604030504040204" pitchFamily="34" charset="0"/>
                <a:cs typeface="Times New Roman" panose="02020603050405020304" pitchFamily="18" charset="0"/>
              </a:rPr>
              <a:t>Figure S1. </a:t>
            </a:r>
            <a:r>
              <a:rPr lang="en-GB" sz="1000" dirty="0">
                <a:ea typeface="Tahoma" panose="020B0604030504040204" pitchFamily="34" charset="0"/>
                <a:cs typeface="Times New Roman" panose="02020603050405020304" pitchFamily="18" charset="0"/>
              </a:rPr>
              <a:t>Flow diagram of study. </a:t>
            </a:r>
            <a:r>
              <a:rPr lang="en-US" sz="1000" dirty="0">
                <a:ea typeface="Tahoma" panose="020B0604030504040204" pitchFamily="34" charset="0"/>
                <a:cs typeface="Times New Roman" panose="02020603050405020304" pitchFamily="18" charset="0"/>
              </a:rPr>
              <a:t>From the 1st of February 2020 to March 2022, there were 35,028 doctors that were publicly employed. </a:t>
            </a:r>
            <a:endParaRPr lang="en-GB" sz="1000" dirty="0">
              <a:ea typeface="Tahoma" panose="020B060403050404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7B3D4E2-7C97-479F-871F-824577563479}"/>
              </a:ext>
            </a:extLst>
          </p:cNvPr>
          <p:cNvSpPr txBox="1"/>
          <p:nvPr/>
        </p:nvSpPr>
        <p:spPr>
          <a:xfrm>
            <a:off x="2106906" y="862885"/>
            <a:ext cx="2206311" cy="5539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blicly employed doctors in Sweden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bruary 2020 – March 2022</a:t>
            </a:r>
          </a:p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= 40,107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D2C7667-EAFB-4C45-9980-9280EDDD6206}"/>
              </a:ext>
            </a:extLst>
          </p:cNvPr>
          <p:cNvSpPr txBox="1"/>
          <p:nvPr/>
        </p:nvSpPr>
        <p:spPr>
          <a:xfrm>
            <a:off x="144082" y="2071352"/>
            <a:ext cx="1671838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bruary – December 2020</a:t>
            </a:r>
          </a:p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= 36,575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C803DFE-62C9-49B6-B3F0-D960B5956C72}"/>
              </a:ext>
            </a:extLst>
          </p:cNvPr>
          <p:cNvSpPr txBox="1"/>
          <p:nvPr/>
        </p:nvSpPr>
        <p:spPr>
          <a:xfrm>
            <a:off x="2374138" y="2069206"/>
            <a:ext cx="1671838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anuary – June 2021</a:t>
            </a:r>
          </a:p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= 37,458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42C0BBA-50DB-4C83-925F-4A569BA5B431}"/>
              </a:ext>
            </a:extLst>
          </p:cNvPr>
          <p:cNvSpPr txBox="1"/>
          <p:nvPr/>
        </p:nvSpPr>
        <p:spPr>
          <a:xfrm>
            <a:off x="4497004" y="2079938"/>
            <a:ext cx="1671838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uly 2021 – March 2022</a:t>
            </a:r>
          </a:p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= 37,458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955B618-04FA-4588-BC75-22D098210B9A}"/>
              </a:ext>
            </a:extLst>
          </p:cNvPr>
          <p:cNvSpPr txBox="1"/>
          <p:nvPr/>
        </p:nvSpPr>
        <p:spPr>
          <a:xfrm>
            <a:off x="141935" y="3524518"/>
            <a:ext cx="1671838" cy="132343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bruary – December 2020</a:t>
            </a:r>
          </a:p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= 32,098</a:t>
            </a:r>
          </a:p>
          <a:p>
            <a:pPr algn="ctr"/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ference category: </a:t>
            </a:r>
          </a:p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= 3,063</a:t>
            </a:r>
          </a:p>
          <a:p>
            <a:pPr algn="ctr"/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osure category:</a:t>
            </a:r>
          </a:p>
          <a:p>
            <a:pPr algn="ctr"/>
            <a:r>
              <a:rPr lang="en-GB" sz="1000">
                <a:latin typeface="Times New Roman" panose="02020603050405020304" pitchFamily="18" charset="0"/>
                <a:cs typeface="Times New Roman" panose="02020603050405020304" pitchFamily="18" charset="0"/>
              </a:rPr>
              <a:t>N = 29,035</a:t>
            </a:r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1567B02-1154-4E25-A243-C643719B75F9}"/>
              </a:ext>
            </a:extLst>
          </p:cNvPr>
          <p:cNvSpPr txBox="1"/>
          <p:nvPr/>
        </p:nvSpPr>
        <p:spPr>
          <a:xfrm>
            <a:off x="2384870" y="3522372"/>
            <a:ext cx="1671838" cy="132343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anuary – June 2021</a:t>
            </a:r>
          </a:p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= 32,654</a:t>
            </a:r>
          </a:p>
          <a:p>
            <a:pPr algn="ctr"/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ference category:</a:t>
            </a:r>
          </a:p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= 3,143</a:t>
            </a:r>
          </a:p>
          <a:p>
            <a:pPr algn="ctr"/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osure category:</a:t>
            </a:r>
          </a:p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= 29,51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9F00FC4-AE2B-4644-BC17-D67C2D54200D}"/>
              </a:ext>
            </a:extLst>
          </p:cNvPr>
          <p:cNvSpPr txBox="1"/>
          <p:nvPr/>
        </p:nvSpPr>
        <p:spPr>
          <a:xfrm>
            <a:off x="4494857" y="3533104"/>
            <a:ext cx="1671838" cy="132343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uly 2021 – March 2022</a:t>
            </a:r>
          </a:p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= 32,654</a:t>
            </a:r>
          </a:p>
          <a:p>
            <a:pPr algn="ctr"/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ference category:</a:t>
            </a:r>
          </a:p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= 3,143</a:t>
            </a:r>
          </a:p>
          <a:p>
            <a:pPr algn="ctr"/>
            <a:endParaRPr lang="en-GB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osure category:</a:t>
            </a:r>
          </a:p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= 29,511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69806EE6-4D85-4982-A7A5-863C10C95A59}"/>
              </a:ext>
            </a:extLst>
          </p:cNvPr>
          <p:cNvCxnSpPr>
            <a:stCxn id="5" idx="2"/>
            <a:endCxn id="7" idx="0"/>
          </p:cNvCxnSpPr>
          <p:nvPr/>
        </p:nvCxnSpPr>
        <p:spPr>
          <a:xfrm flipH="1">
            <a:off x="3210057" y="1416883"/>
            <a:ext cx="5" cy="65232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B9958C96-8BD2-4626-9FB3-095C1DCD6786}"/>
              </a:ext>
            </a:extLst>
          </p:cNvPr>
          <p:cNvCxnSpPr>
            <a:cxnSpLocks/>
            <a:stCxn id="7" idx="2"/>
            <a:endCxn id="10" idx="0"/>
          </p:cNvCxnSpPr>
          <p:nvPr/>
        </p:nvCxnSpPr>
        <p:spPr>
          <a:xfrm>
            <a:off x="3210057" y="2469316"/>
            <a:ext cx="10732" cy="105305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3E69F51A-418A-4A79-A9F7-DBC97331A954}"/>
              </a:ext>
            </a:extLst>
          </p:cNvPr>
          <p:cNvCxnSpPr>
            <a:cxnSpLocks/>
            <a:stCxn id="6" idx="2"/>
            <a:endCxn id="9" idx="0"/>
          </p:cNvCxnSpPr>
          <p:nvPr/>
        </p:nvCxnSpPr>
        <p:spPr>
          <a:xfrm flipH="1">
            <a:off x="977854" y="2471462"/>
            <a:ext cx="2147" cy="105305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0C425E1B-B3BF-4276-B640-8C4AF7C23C91}"/>
              </a:ext>
            </a:extLst>
          </p:cNvPr>
          <p:cNvCxnSpPr>
            <a:cxnSpLocks/>
            <a:stCxn id="8" idx="2"/>
            <a:endCxn id="11" idx="0"/>
          </p:cNvCxnSpPr>
          <p:nvPr/>
        </p:nvCxnSpPr>
        <p:spPr>
          <a:xfrm flipH="1">
            <a:off x="5330776" y="2480048"/>
            <a:ext cx="2147" cy="105305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ctor: Elbow 15">
            <a:extLst>
              <a:ext uri="{FF2B5EF4-FFF2-40B4-BE49-F238E27FC236}">
                <a16:creationId xmlns:a16="http://schemas.microsoft.com/office/drawing/2014/main" id="{A7EB11A5-8E09-4B12-8E55-5C4ED340FEEA}"/>
              </a:ext>
            </a:extLst>
          </p:cNvPr>
          <p:cNvCxnSpPr>
            <a:stCxn id="5" idx="2"/>
            <a:endCxn id="8" idx="0"/>
          </p:cNvCxnSpPr>
          <p:nvPr/>
        </p:nvCxnSpPr>
        <p:spPr>
          <a:xfrm rot="16200000" flipH="1">
            <a:off x="3939965" y="686979"/>
            <a:ext cx="663055" cy="2122861"/>
          </a:xfrm>
          <a:prstGeom prst="bentConnector3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nector: Elbow 16">
            <a:extLst>
              <a:ext uri="{FF2B5EF4-FFF2-40B4-BE49-F238E27FC236}">
                <a16:creationId xmlns:a16="http://schemas.microsoft.com/office/drawing/2014/main" id="{61B20D37-F138-4E51-AC5D-77E7155DEA79}"/>
              </a:ext>
            </a:extLst>
          </p:cNvPr>
          <p:cNvCxnSpPr>
            <a:cxnSpLocks/>
            <a:stCxn id="5" idx="2"/>
            <a:endCxn id="6" idx="0"/>
          </p:cNvCxnSpPr>
          <p:nvPr/>
        </p:nvCxnSpPr>
        <p:spPr>
          <a:xfrm rot="5400000">
            <a:off x="1767798" y="629087"/>
            <a:ext cx="654469" cy="2230061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742780E7-FF9F-484F-A738-FEBA5A9C0E30}"/>
              </a:ext>
            </a:extLst>
          </p:cNvPr>
          <p:cNvSpPr txBox="1"/>
          <p:nvPr/>
        </p:nvSpPr>
        <p:spPr>
          <a:xfrm>
            <a:off x="1247372" y="2672366"/>
            <a:ext cx="1212492" cy="707886"/>
          </a:xfrm>
          <a:prstGeom prst="rect">
            <a:avLst/>
          </a:prstGeom>
          <a:noFill/>
          <a:ln>
            <a:solidFill>
              <a:schemeClr val="tx1"/>
            </a:solidFill>
            <a:prstDash val="sysDot"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sion</a:t>
            </a:r>
          </a:p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cialty unknown: n = 4,476</a:t>
            </a:r>
          </a:p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 unknown: 1</a:t>
            </a:r>
          </a:p>
        </p:txBody>
      </p:sp>
      <p:cxnSp>
        <p:nvCxnSpPr>
          <p:cNvPr id="19" name="Connector: Elbow 18">
            <a:extLst>
              <a:ext uri="{FF2B5EF4-FFF2-40B4-BE49-F238E27FC236}">
                <a16:creationId xmlns:a16="http://schemas.microsoft.com/office/drawing/2014/main" id="{29C1ED71-6B00-4285-A7CD-9B427E0D331E}"/>
              </a:ext>
            </a:extLst>
          </p:cNvPr>
          <p:cNvCxnSpPr>
            <a:cxnSpLocks/>
            <a:stCxn id="6" idx="2"/>
            <a:endCxn id="18" idx="1"/>
          </p:cNvCxnSpPr>
          <p:nvPr/>
        </p:nvCxnSpPr>
        <p:spPr>
          <a:xfrm rot="16200000" flipH="1">
            <a:off x="836263" y="2615199"/>
            <a:ext cx="554847" cy="267371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24A26DD6-8439-4D67-80F2-B0BABAECB50E}"/>
              </a:ext>
            </a:extLst>
          </p:cNvPr>
          <p:cNvSpPr txBox="1"/>
          <p:nvPr/>
        </p:nvSpPr>
        <p:spPr>
          <a:xfrm>
            <a:off x="3447513" y="2644462"/>
            <a:ext cx="1212492" cy="553998"/>
          </a:xfrm>
          <a:prstGeom prst="rect">
            <a:avLst/>
          </a:prstGeom>
          <a:noFill/>
          <a:ln>
            <a:solidFill>
              <a:schemeClr val="tx1"/>
            </a:solidFill>
            <a:prstDash val="sysDot"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sion</a:t>
            </a:r>
          </a:p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cialty unknown: n = 4,804</a:t>
            </a:r>
          </a:p>
        </p:txBody>
      </p:sp>
      <p:cxnSp>
        <p:nvCxnSpPr>
          <p:cNvPr id="21" name="Connector: Elbow 20">
            <a:extLst>
              <a:ext uri="{FF2B5EF4-FFF2-40B4-BE49-F238E27FC236}">
                <a16:creationId xmlns:a16="http://schemas.microsoft.com/office/drawing/2014/main" id="{4202F920-D8D5-4B57-97D6-4DF99CD201BC}"/>
              </a:ext>
            </a:extLst>
          </p:cNvPr>
          <p:cNvCxnSpPr>
            <a:cxnSpLocks/>
            <a:stCxn id="7" idx="2"/>
            <a:endCxn id="20" idx="1"/>
          </p:cNvCxnSpPr>
          <p:nvPr/>
        </p:nvCxnSpPr>
        <p:spPr>
          <a:xfrm rot="16200000" flipH="1">
            <a:off x="3102713" y="2576660"/>
            <a:ext cx="452145" cy="237456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nector: Elbow 21">
            <a:extLst>
              <a:ext uri="{FF2B5EF4-FFF2-40B4-BE49-F238E27FC236}">
                <a16:creationId xmlns:a16="http://schemas.microsoft.com/office/drawing/2014/main" id="{ED53FC93-24C3-46B2-B5F3-916826CBB1BE}"/>
              </a:ext>
            </a:extLst>
          </p:cNvPr>
          <p:cNvCxnSpPr>
            <a:cxnSpLocks/>
            <a:stCxn id="8" idx="2"/>
            <a:endCxn id="23" idx="1"/>
          </p:cNvCxnSpPr>
          <p:nvPr/>
        </p:nvCxnSpPr>
        <p:spPr>
          <a:xfrm rot="16200000" flipH="1">
            <a:off x="5180504" y="2632466"/>
            <a:ext cx="532463" cy="227625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E8AC5C34-9850-4FD2-B92D-B23FEAD7AFF1}"/>
              </a:ext>
            </a:extLst>
          </p:cNvPr>
          <p:cNvSpPr txBox="1"/>
          <p:nvPr/>
        </p:nvSpPr>
        <p:spPr>
          <a:xfrm>
            <a:off x="5560548" y="2735512"/>
            <a:ext cx="1212492" cy="553998"/>
          </a:xfrm>
          <a:prstGeom prst="rect">
            <a:avLst/>
          </a:prstGeom>
          <a:noFill/>
          <a:ln>
            <a:solidFill>
              <a:schemeClr val="tx1"/>
            </a:solidFill>
            <a:prstDash val="sysDot"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sion</a:t>
            </a:r>
          </a:p>
          <a:p>
            <a:pPr algn="ctr"/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cialty unknown: n = 4,804</a:t>
            </a:r>
          </a:p>
        </p:txBody>
      </p:sp>
    </p:spTree>
    <p:extLst>
      <p:ext uri="{BB962C8B-B14F-4D97-AF65-F5344CB8AC3E}">
        <p14:creationId xmlns:p14="http://schemas.microsoft.com/office/powerpoint/2010/main" val="36590328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AA799586-C59C-4943-9FE9-1621A2AA80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3333" y="262466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pic>
        <p:nvPicPr>
          <p:cNvPr id="1025" name="Picture 1">
            <a:extLst>
              <a:ext uri="{FF2B5EF4-FFF2-40B4-BE49-F238E27FC236}">
                <a16:creationId xmlns:a16="http://schemas.microsoft.com/office/drawing/2014/main" id="{385C7A42-F591-4629-A385-14B03F65AE1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3333" y="719666"/>
            <a:ext cx="5943600" cy="47561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3">
            <a:extLst>
              <a:ext uri="{FF2B5EF4-FFF2-40B4-BE49-F238E27FC236}">
                <a16:creationId xmlns:a16="http://schemas.microsoft.com/office/drawing/2014/main" id="{53E654AA-8FB2-46A5-B9D2-CFAE997EFB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2400" y="180631"/>
            <a:ext cx="4749800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sv-SE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2: </a:t>
            </a:r>
            <a:r>
              <a:rPr kumimoji="0" lang="en-US" altLang="sv-SE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aplan Maier curve by </a:t>
            </a:r>
            <a:r>
              <a:rPr kumimoji="0" lang="en-US" altLang="sv-SE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ccupational clinic</a:t>
            </a:r>
            <a:r>
              <a:rPr kumimoji="0" lang="en-US" altLang="sv-SE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kumimoji="0" lang="en-US" altLang="sv-SE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Period 1 (Feb/2020 to Dec/2020).</a:t>
            </a:r>
            <a:endParaRPr kumimoji="0" lang="en-US" altLang="sv-SE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770157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F356D482-BA3A-4506-86EB-EF74D74260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pic>
        <p:nvPicPr>
          <p:cNvPr id="2049" name="Picture 2" descr="A graph with different colored lines&#10;&#10;Description automatically generated">
            <a:extLst>
              <a:ext uri="{FF2B5EF4-FFF2-40B4-BE49-F238E27FC236}">
                <a16:creationId xmlns:a16="http://schemas.microsoft.com/office/drawing/2014/main" id="{9F43014F-FB04-4E88-87B5-C54931056F6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133" y="584200"/>
            <a:ext cx="5943600" cy="47561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3">
            <a:extLst>
              <a:ext uri="{FF2B5EF4-FFF2-40B4-BE49-F238E27FC236}">
                <a16:creationId xmlns:a16="http://schemas.microsoft.com/office/drawing/2014/main" id="{EE3388E0-7577-4CDE-90A3-2A6DB3809A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1667" y="145706"/>
            <a:ext cx="4546437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sv-SE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3: </a:t>
            </a:r>
            <a:r>
              <a:rPr kumimoji="0" lang="en-US" altLang="sv-SE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aplan Maier curve by </a:t>
            </a:r>
            <a:r>
              <a:rPr kumimoji="0" lang="en-US" altLang="sv-SE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ccupational clinic</a:t>
            </a:r>
            <a:r>
              <a:rPr kumimoji="0" lang="en-US" altLang="sv-SE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kumimoji="0" lang="en-US" altLang="sv-SE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Period 2 (Jan/2021 to Jun/2021).</a:t>
            </a:r>
            <a:endParaRPr kumimoji="0" lang="en-US" altLang="sv-SE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604791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565992EE-9885-4A41-BC72-16A69BF016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pic>
        <p:nvPicPr>
          <p:cNvPr id="3073" name="Picture 3" descr="A graph of different colored lines&#10;&#10;Description automatically generated">
            <a:extLst>
              <a:ext uri="{FF2B5EF4-FFF2-40B4-BE49-F238E27FC236}">
                <a16:creationId xmlns:a16="http://schemas.microsoft.com/office/drawing/2014/main" id="{62E7D7FD-22C4-4CC4-BCB6-9D18A447695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57200"/>
            <a:ext cx="5943600" cy="47561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3">
            <a:extLst>
              <a:ext uri="{FF2B5EF4-FFF2-40B4-BE49-F238E27FC236}">
                <a16:creationId xmlns:a16="http://schemas.microsoft.com/office/drawing/2014/main" id="{2A6639D3-92EF-4A15-939F-E4866ABA70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2400" y="162640"/>
            <a:ext cx="4592924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sv-SE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4: </a:t>
            </a:r>
            <a:r>
              <a:rPr kumimoji="0" lang="en-US" altLang="sv-SE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aplan Maier curve by </a:t>
            </a:r>
            <a:r>
              <a:rPr kumimoji="0" lang="en-US" altLang="sv-SE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ccupational clinic</a:t>
            </a:r>
            <a:r>
              <a:rPr kumimoji="0" lang="en-US" altLang="sv-SE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kumimoji="0" lang="en-US" altLang="sv-SE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Period 3 (Jul/2021 to Mar/2022). </a:t>
            </a:r>
            <a:endParaRPr kumimoji="0" lang="en-US" altLang="sv-SE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19879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BD6C4299-8C40-406E-BD07-ACC38DC7971F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pic>
        <p:nvPicPr>
          <p:cNvPr id="4097" name="Picture 2">
            <a:extLst>
              <a:ext uri="{FF2B5EF4-FFF2-40B4-BE49-F238E27FC236}">
                <a16:creationId xmlns:a16="http://schemas.microsoft.com/office/drawing/2014/main" id="{1D813366-30D3-4EB5-9A0B-B066E9CB6AA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57200"/>
            <a:ext cx="6686550" cy="5016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3">
            <a:extLst>
              <a:ext uri="{FF2B5EF4-FFF2-40B4-BE49-F238E27FC236}">
                <a16:creationId xmlns:a16="http://schemas.microsoft.com/office/drawing/2014/main" id="{C81923D7-B5EC-44D2-870C-3DA9B7BB174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5534" y="-68049"/>
            <a:ext cx="2568332" cy="4154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br>
              <a:rPr kumimoji="0" lang="en-US" altLang="sv-SE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kumimoji="0" lang="en-US" altLang="sv-SE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5: </a:t>
            </a:r>
            <a:r>
              <a:rPr kumimoji="0" lang="en-US" altLang="sv-SE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choenfeld test plot per subperiod.</a:t>
            </a:r>
            <a:endParaRPr kumimoji="0" lang="en-US" altLang="sv-SE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148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D1EAFCEA49E8D6499A4B84E74580004B" ma:contentTypeVersion="6" ma:contentTypeDescription="Skapa ett nytt dokument." ma:contentTypeScope="" ma:versionID="8bb000d7198fb21ebdd3cfa53ff943bf">
  <xsd:schema xmlns:xsd="http://www.w3.org/2001/XMLSchema" xmlns:xs="http://www.w3.org/2001/XMLSchema" xmlns:p="http://schemas.microsoft.com/office/2006/metadata/properties" xmlns:ns2="c3daafb9-d087-42ae-aa61-efb37c3c02bc" xmlns:ns3="921f50f2-74b9-4fe8-bff6-6d563a9805d5" targetNamespace="http://schemas.microsoft.com/office/2006/metadata/properties" ma:root="true" ma:fieldsID="72ac0a8348574676c87c9db3a4ee9bfb" ns2:_="" ns3:_="">
    <xsd:import namespace="c3daafb9-d087-42ae-aa61-efb37c3c02bc"/>
    <xsd:import namespace="921f50f2-74b9-4fe8-bff6-6d563a9805d5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ObjectDetectorVersions" minOccurs="0"/>
                <xsd:element ref="ns3:SharedWithUsers" minOccurs="0"/>
                <xsd:element ref="ns3:SharedWithDetail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3daafb9-d087-42ae-aa61-efb37c3c02b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3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21f50f2-74b9-4fe8-bff6-6d563a9805d5" elementFormDefault="qualified">
    <xsd:import namespace="http://schemas.microsoft.com/office/2006/documentManagement/types"/>
    <xsd:import namespace="http://schemas.microsoft.com/office/infopath/2007/PartnerControls"/>
    <xsd:element name="SharedWithUsers" ma:index="11" nillable="true" ma:displayName="Delat med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2" nillable="true" ma:displayName="Delat med information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nehållstyp"/>
        <xsd:element ref="dc:title" minOccurs="0" maxOccurs="1" ma:index="4" ma:displayName="Rubrik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3A7024E6-5152-4E97-92E2-A86609AC8FA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3daafb9-d087-42ae-aa61-efb37c3c02bc"/>
    <ds:schemaRef ds:uri="921f50f2-74b9-4fe8-bff6-6d563a9805d5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BE5F1C48-C077-4FD2-9292-E359A667D9C9}">
  <ds:schemaRefs>
    <ds:schemaRef ds:uri="http://schemas.microsoft.com/office/2006/documentManagement/types"/>
    <ds:schemaRef ds:uri="921f50f2-74b9-4fe8-bff6-6d563a9805d5"/>
    <ds:schemaRef ds:uri="c3daafb9-d087-42ae-aa61-efb37c3c02bc"/>
    <ds:schemaRef ds:uri="http://purl.org/dc/elements/1.1/"/>
    <ds:schemaRef ds:uri="http://schemas.microsoft.com/office/2006/metadata/properties"/>
    <ds:schemaRef ds:uri="http://purl.org/dc/terms/"/>
    <ds:schemaRef ds:uri="http://schemas.openxmlformats.org/package/2006/metadata/core-properties"/>
    <ds:schemaRef ds:uri="http://schemas.microsoft.com/office/infopath/2007/PartnerControls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9550DD22-B5D9-48B5-9491-DE1F58D24600}">
  <ds:schemaRefs>
    <ds:schemaRef ds:uri="http://schemas.microsoft.com/sharepoint/v3/contenttype/forms"/>
  </ds:schemaRefs>
</ds:datastoreItem>
</file>

<file path=docMetadata/LabelInfo.xml><?xml version="1.0" encoding="utf-8"?>
<clbl:labelList xmlns:clbl="http://schemas.microsoft.com/office/2020/mipLabelMetadata">
  <clbl:label id="{f13b610e-d3b5-490f-b165-988100e8232a}" enabled="1" method="Standard" siteId="{5a4ba6f9-f531-4f32-9467-398f19e69de4}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</TotalTime>
  <Words>218</Words>
  <Application>Microsoft Office PowerPoint</Application>
  <PresentationFormat>A4 Paper (210x297 mm)</PresentationFormat>
  <Paragraphs>44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MS Mincho</vt:lpstr>
      <vt:lpstr>Arial</vt:lpstr>
      <vt:lpstr>Calibri</vt:lpstr>
      <vt:lpstr>Calibri Light</vt:lpstr>
      <vt:lpstr>Tahoma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e-Marie Fors Connolly</dc:creator>
  <cp:lastModifiedBy>Anne-Marie Connolly Fors</cp:lastModifiedBy>
  <cp:revision>12</cp:revision>
  <dcterms:created xsi:type="dcterms:W3CDTF">2024-01-26T15:06:49Z</dcterms:created>
  <dcterms:modified xsi:type="dcterms:W3CDTF">2024-09-27T14:51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1EAFCEA49E8D6499A4B84E74580004B</vt:lpwstr>
  </property>
  <property fmtid="{D5CDD505-2E9C-101B-9397-08002B2CF9AE}" pid="3" name="ClassificationContentMarkingHeaderLocations">
    <vt:lpwstr>Office Theme:8</vt:lpwstr>
  </property>
  <property fmtid="{D5CDD505-2E9C-101B-9397-08002B2CF9AE}" pid="4" name="ClassificationContentMarkingHeaderText">
    <vt:lpwstr>Begränsad delning</vt:lpwstr>
  </property>
</Properties>
</file>